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264275" cy="8389938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3">
          <p15:clr>
            <a:srgbClr val="A4A3A4"/>
          </p15:clr>
        </p15:guide>
        <p15:guide id="2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FCFCF"/>
    <a:srgbClr val="C2C2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3090" y="90"/>
      </p:cViewPr>
      <p:guideLst>
        <p:guide orient="horz" pos="264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F9EDD-3E68-46B4-9C12-C3B63D6C7EE9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685800"/>
            <a:ext cx="25590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759E7D-5FF2-4BC7-A7C3-E1D7CA0F835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77960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759E7D-5FF2-4BC7-A7C3-E1D7CA0F8354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234372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469821" y="2606319"/>
            <a:ext cx="5324634" cy="1798399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939641" y="4754298"/>
            <a:ext cx="4384993" cy="21440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35810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0665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111475" y="411729"/>
            <a:ext cx="965742" cy="875699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14247" y="411729"/>
            <a:ext cx="2792823" cy="875699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35638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69788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4834" y="5391313"/>
            <a:ext cx="5324634" cy="166633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4834" y="3556014"/>
            <a:ext cx="5324634" cy="183529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6723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14247" y="2394629"/>
            <a:ext cx="1879283" cy="677409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197934" y="2394629"/>
            <a:ext cx="1879283" cy="677409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35009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13214" y="335987"/>
            <a:ext cx="5637848" cy="1398323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13214" y="1878026"/>
            <a:ext cx="2767809" cy="782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13214" y="2660698"/>
            <a:ext cx="2767809" cy="48339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182165" y="1878026"/>
            <a:ext cx="2768897" cy="782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182165" y="2660698"/>
            <a:ext cx="2768897" cy="48339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07390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24694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48604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13214" y="334044"/>
            <a:ext cx="2060903" cy="142162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449157" y="334044"/>
            <a:ext cx="3501904" cy="716058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13214" y="1755673"/>
            <a:ext cx="2060903" cy="57389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32746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227842" y="5872956"/>
            <a:ext cx="3758565" cy="69333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227842" y="749656"/>
            <a:ext cx="3758565" cy="50339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227842" y="6566292"/>
            <a:ext cx="3758565" cy="98465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1966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13214" y="335987"/>
            <a:ext cx="5637848" cy="13983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13214" y="1957653"/>
            <a:ext cx="5637848" cy="55369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13214" y="7776230"/>
            <a:ext cx="1461664" cy="446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ED922-EFE4-458C-8439-EE8FFD51C262}" type="datetimeFigureOut">
              <a:rPr lang="es-MX" smtClean="0"/>
              <a:t>28/03/202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140294" y="7776230"/>
            <a:ext cx="1983687" cy="446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489397" y="7776230"/>
            <a:ext cx="1461664" cy="446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81BF4-92FA-48A1-AE4F-BF5007056F8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32568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7.png"/><Relationship Id="rId3" Type="http://schemas.openxmlformats.org/officeDocument/2006/relationships/oleObject" Target="file:///C:\Users\LEDESMA\Desktop\Yadira\Gr&#225;fica%20dexa%20y%20curva%20tces%20120325\P&#233;rdida%20de%20peso%20CURVA%20TcES.pzf!G1" TargetMode="External"/><Relationship Id="rId7" Type="http://schemas.openxmlformats.org/officeDocument/2006/relationships/image" Target="../media/image3.png"/><Relationship Id="rId12" Type="http://schemas.openxmlformats.org/officeDocument/2006/relationships/image" Target="../media/image6.png"/><Relationship Id="rId17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oleObject" Target="file:///C:\Users\LEDESMA\Downloads\Longitud%20colon%20curva%20TcES170325.pzf!G0" TargetMode="Externa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file:///C:\Users\LEDESMA\Desktop\Yadira\Gr&#225;fica%20dexa%20y%20curva%20tces%20120325\DAI%20DEXA%20%20y%20Curva%20TcES(10).pzf!G1" TargetMode="External"/><Relationship Id="rId15" Type="http://schemas.openxmlformats.org/officeDocument/2006/relationships/image" Target="../media/image9.png"/><Relationship Id="rId10" Type="http://schemas.microsoft.com/office/2007/relationships/hdphoto" Target="../media/hdphoto2.wdp"/><Relationship Id="rId4" Type="http://schemas.openxmlformats.org/officeDocument/2006/relationships/image" Target="../media/image1.emf"/><Relationship Id="rId9" Type="http://schemas.openxmlformats.org/officeDocument/2006/relationships/image" Target="../media/image4.png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51817" y="306537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aphicFrame>
        <p:nvGraphicFramePr>
          <p:cNvPr id="5" name="4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0968100"/>
              </p:ext>
            </p:extLst>
          </p:nvPr>
        </p:nvGraphicFramePr>
        <p:xfrm>
          <a:off x="107801" y="781718"/>
          <a:ext cx="3103511" cy="1613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5104203" imgH="2652895" progId="Prism6.Document">
                  <p:link updateAutomatic="1"/>
                </p:oleObj>
              </mc:Choice>
              <mc:Fallback>
                <p:oleObj name="Prism 6" r:id="rId3" imgW="5104203" imgH="2652895" progId="Prism6.Document">
                  <p:link updateAutomatic="1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801" y="781718"/>
                        <a:ext cx="3103511" cy="16130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5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0084994"/>
              </p:ext>
            </p:extLst>
          </p:nvPr>
        </p:nvGraphicFramePr>
        <p:xfrm>
          <a:off x="3276153" y="810593"/>
          <a:ext cx="2887797" cy="15952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4802410" imgH="2652895" progId="Prism6.Document">
                  <p:link updateAutomatic="1"/>
                </p:oleObj>
              </mc:Choice>
              <mc:Fallback>
                <p:oleObj name="Prism 6" r:id="rId5" imgW="4802410" imgH="2652895" progId="Prism6.Document">
                  <p:link updateAutomatic="1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76153" y="810593"/>
                        <a:ext cx="2887797" cy="15952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6 CuadroTexto"/>
          <p:cNvSpPr txBox="1"/>
          <p:nvPr/>
        </p:nvSpPr>
        <p:spPr>
          <a:xfrm>
            <a:off x="251817" y="2466777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pSp>
        <p:nvGrpSpPr>
          <p:cNvPr id="40" name="39 Grupo"/>
          <p:cNvGrpSpPr/>
          <p:nvPr/>
        </p:nvGrpSpPr>
        <p:grpSpPr>
          <a:xfrm>
            <a:off x="597048" y="2669317"/>
            <a:ext cx="2461231" cy="2164297"/>
            <a:chOff x="862417" y="5993914"/>
            <a:chExt cx="2461231" cy="2164297"/>
          </a:xfrm>
        </p:grpSpPr>
        <p:pic>
          <p:nvPicPr>
            <p:cNvPr id="18" name="Imagen 6">
              <a:extLst>
                <a:ext uri="{FF2B5EF4-FFF2-40B4-BE49-F238E27FC236}">
                  <a16:creationId xmlns:a16="http://schemas.microsoft.com/office/drawing/2014/main" id="{93BB3E2C-4E82-E5DF-6C10-A5B1228E48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80208" t="404" r="1979"/>
            <a:stretch/>
          </p:blipFill>
          <p:spPr>
            <a:xfrm rot="16200000">
              <a:off x="2329266" y="6702930"/>
              <a:ext cx="406764" cy="156608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9" name="Imagen 8">
              <a:extLst>
                <a:ext uri="{FF2B5EF4-FFF2-40B4-BE49-F238E27FC236}">
                  <a16:creationId xmlns:a16="http://schemas.microsoft.com/office/drawing/2014/main" id="{39DE2449-1B35-EAE0-A821-0F915DC210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1593" b="89977" l="46695" r="55272"/>
                      </a14:imgEffect>
                      <a14:imgEffect>
                        <a14:saturation sat="155000"/>
                      </a14:imgEffect>
                    </a14:imgLayer>
                  </a14:imgProps>
                </a:ext>
              </a:extLst>
            </a:blip>
            <a:srcRect l="45606" r="43468" b="-282"/>
            <a:stretch/>
          </p:blipFill>
          <p:spPr>
            <a:xfrm rot="16200000">
              <a:off x="2344641" y="7071878"/>
              <a:ext cx="387303" cy="1570711"/>
            </a:xfrm>
            <a:prstGeom prst="rect">
              <a:avLst/>
            </a:prstGeom>
            <a:solidFill>
              <a:srgbClr val="CFCFCF"/>
            </a:solidFill>
            <a:ln w="19050">
              <a:solidFill>
                <a:schemeClr val="tx1"/>
              </a:solidFill>
            </a:ln>
          </p:spPr>
        </p:pic>
        <p:pic>
          <p:nvPicPr>
            <p:cNvPr id="20" name="Imagen 6">
              <a:extLst>
                <a:ext uri="{FF2B5EF4-FFF2-40B4-BE49-F238E27FC236}">
                  <a16:creationId xmlns:a16="http://schemas.microsoft.com/office/drawing/2014/main" id="{93BB3E2C-4E82-E5DF-6C10-A5B1228E48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53011" t="289" r="29343"/>
            <a:stretch/>
          </p:blipFill>
          <p:spPr>
            <a:xfrm rot="16200000">
              <a:off x="2327411" y="6276429"/>
              <a:ext cx="405078" cy="157074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1" name="Imagen 6">
              <a:extLst>
                <a:ext uri="{FF2B5EF4-FFF2-40B4-BE49-F238E27FC236}">
                  <a16:creationId xmlns:a16="http://schemas.microsoft.com/office/drawing/2014/main" id="{93BB3E2C-4E82-E5DF-6C10-A5B1228E48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33628" t="289" r="48726"/>
            <a:stretch/>
          </p:blipFill>
          <p:spPr>
            <a:xfrm rot="16200000">
              <a:off x="2329925" y="5852460"/>
              <a:ext cx="405078" cy="156571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2" name="Imagen 6">
              <a:extLst>
                <a:ext uri="{FF2B5EF4-FFF2-40B4-BE49-F238E27FC236}">
                  <a16:creationId xmlns:a16="http://schemas.microsoft.com/office/drawing/2014/main" id="{93BB3E2C-4E82-E5DF-6C10-A5B1228E48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13467" r="68887" b="289"/>
            <a:stretch/>
          </p:blipFill>
          <p:spPr>
            <a:xfrm rot="16200000">
              <a:off x="2335753" y="5411099"/>
              <a:ext cx="405079" cy="157071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3" name="2 CuadroTexto"/>
            <p:cNvSpPr txBox="1"/>
            <p:nvPr/>
          </p:nvSpPr>
          <p:spPr>
            <a:xfrm>
              <a:off x="899889" y="6067177"/>
              <a:ext cx="7726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23" name="22 CuadroTexto"/>
            <p:cNvSpPr txBox="1"/>
            <p:nvPr/>
          </p:nvSpPr>
          <p:spPr>
            <a:xfrm>
              <a:off x="899889" y="6496576"/>
              <a:ext cx="7726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SS</a:t>
              </a:r>
            </a:p>
          </p:txBody>
        </p:sp>
        <p:sp>
          <p:nvSpPr>
            <p:cNvPr id="24" name="23 CuadroTexto"/>
            <p:cNvSpPr txBox="1"/>
            <p:nvPr/>
          </p:nvSpPr>
          <p:spPr>
            <a:xfrm>
              <a:off x="899889" y="6787257"/>
              <a:ext cx="9361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00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25" name="24 CuadroTexto"/>
            <p:cNvSpPr txBox="1"/>
            <p:nvPr/>
          </p:nvSpPr>
          <p:spPr>
            <a:xfrm>
              <a:off x="862417" y="7219305"/>
              <a:ext cx="9361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00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26" name="25 CuadroTexto"/>
            <p:cNvSpPr txBox="1"/>
            <p:nvPr/>
          </p:nvSpPr>
          <p:spPr>
            <a:xfrm>
              <a:off x="862417" y="7696546"/>
              <a:ext cx="9361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50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</p:grpSp>
      <p:sp>
        <p:nvSpPr>
          <p:cNvPr id="42" name="41 CuadroTexto"/>
          <p:cNvSpPr txBox="1"/>
          <p:nvPr/>
        </p:nvSpPr>
        <p:spPr>
          <a:xfrm>
            <a:off x="256040" y="499809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80C88CEE-7613-689E-0F60-ED9DC1BA664B}"/>
              </a:ext>
            </a:extLst>
          </p:cNvPr>
          <p:cNvGrpSpPr/>
          <p:nvPr/>
        </p:nvGrpSpPr>
        <p:grpSpPr>
          <a:xfrm>
            <a:off x="900878" y="5203081"/>
            <a:ext cx="5111579" cy="1152128"/>
            <a:chOff x="900878" y="5203081"/>
            <a:chExt cx="5111579" cy="1152128"/>
          </a:xfrm>
        </p:grpSpPr>
        <p:pic>
          <p:nvPicPr>
            <p:cNvPr id="45" name="Imagen 13">
              <a:extLst>
                <a:ext uri="{FF2B5EF4-FFF2-40B4-BE49-F238E27FC236}">
                  <a16:creationId xmlns:a16="http://schemas.microsoft.com/office/drawing/2014/main" id="{68AF8A3B-2E78-1855-7463-C9E4DF1C9B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068241" y="5634996"/>
              <a:ext cx="903049" cy="65233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050" name="Picture 26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75953" y="5634993"/>
              <a:ext cx="848957" cy="636106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5" name="Picture 31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04145" y="5647041"/>
              <a:ext cx="842466" cy="63616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61" name="Picture 37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 flipH="1">
              <a:off x="4975872" y="5634993"/>
              <a:ext cx="886803" cy="648207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1" name="Picture 57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2465" y="5634993"/>
              <a:ext cx="829983" cy="65233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41" name="40 CuadroTexto"/>
            <p:cNvSpPr txBox="1"/>
            <p:nvPr/>
          </p:nvSpPr>
          <p:spPr>
            <a:xfrm>
              <a:off x="1570624" y="5352613"/>
              <a:ext cx="6939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66" name="65 CuadroTexto"/>
            <p:cNvSpPr txBox="1"/>
            <p:nvPr/>
          </p:nvSpPr>
          <p:spPr>
            <a:xfrm>
              <a:off x="2510188" y="5352612"/>
              <a:ext cx="6939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SS</a:t>
              </a:r>
            </a:p>
          </p:txBody>
        </p:sp>
        <p:sp>
          <p:nvSpPr>
            <p:cNvPr id="67" name="66 CuadroTexto"/>
            <p:cNvSpPr txBox="1"/>
            <p:nvPr/>
          </p:nvSpPr>
          <p:spPr>
            <a:xfrm>
              <a:off x="3204145" y="5203081"/>
              <a:ext cx="93610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endParaRPr lang="es-MX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00 </a:t>
              </a:r>
              <a:r>
                <a:rPr lang="el-G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68" name="67 CuadroTexto"/>
            <p:cNvSpPr txBox="1"/>
            <p:nvPr/>
          </p:nvSpPr>
          <p:spPr>
            <a:xfrm>
              <a:off x="4140249" y="5203081"/>
              <a:ext cx="93610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endParaRPr lang="es-MX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00 </a:t>
              </a:r>
              <a:r>
                <a:rPr lang="el-G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69" name="68 CuadroTexto"/>
            <p:cNvSpPr txBox="1"/>
            <p:nvPr/>
          </p:nvSpPr>
          <p:spPr>
            <a:xfrm>
              <a:off x="5076353" y="5203081"/>
              <a:ext cx="93610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SS+TcES</a:t>
              </a:r>
              <a:endParaRPr lang="es-MX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50 </a:t>
              </a:r>
              <a:r>
                <a:rPr lang="el-G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s-MX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54" name="53 CuadroTexto"/>
            <p:cNvSpPr txBox="1"/>
            <p:nvPr/>
          </p:nvSpPr>
          <p:spPr>
            <a:xfrm>
              <a:off x="1389135" y="6067177"/>
              <a:ext cx="446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  <p:sp>
          <p:nvSpPr>
            <p:cNvPr id="72" name="71 CuadroTexto"/>
            <p:cNvSpPr txBox="1"/>
            <p:nvPr/>
          </p:nvSpPr>
          <p:spPr>
            <a:xfrm>
              <a:off x="2272923" y="6095773"/>
              <a:ext cx="446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  <p:sp>
          <p:nvSpPr>
            <p:cNvPr id="73" name="72 CuadroTexto"/>
            <p:cNvSpPr txBox="1"/>
            <p:nvPr/>
          </p:nvSpPr>
          <p:spPr>
            <a:xfrm>
              <a:off x="3132137" y="6067177"/>
              <a:ext cx="446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  <p:sp>
          <p:nvSpPr>
            <p:cNvPr id="74" name="73 CuadroTexto"/>
            <p:cNvSpPr txBox="1"/>
            <p:nvPr/>
          </p:nvSpPr>
          <p:spPr>
            <a:xfrm>
              <a:off x="3981423" y="6108988"/>
              <a:ext cx="446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  <p:sp>
          <p:nvSpPr>
            <p:cNvPr id="75" name="74 CuadroTexto"/>
            <p:cNvSpPr txBox="1"/>
            <p:nvPr/>
          </p:nvSpPr>
          <p:spPr>
            <a:xfrm>
              <a:off x="4917527" y="6067177"/>
              <a:ext cx="446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  <p:sp>
          <p:nvSpPr>
            <p:cNvPr id="55" name="54 CuadroTexto"/>
            <p:cNvSpPr txBox="1"/>
            <p:nvPr/>
          </p:nvSpPr>
          <p:spPr>
            <a:xfrm>
              <a:off x="900878" y="5851153"/>
              <a:ext cx="5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&amp;E</a:t>
              </a:r>
            </a:p>
          </p:txBody>
        </p:sp>
      </p:grpSp>
      <p:graphicFrame>
        <p:nvGraphicFramePr>
          <p:cNvPr id="2" name="1 Objet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1306522"/>
              </p:ext>
            </p:extLst>
          </p:nvPr>
        </p:nvGraphicFramePr>
        <p:xfrm>
          <a:off x="3560821" y="2610793"/>
          <a:ext cx="1613940" cy="2232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6" imgW="2424073" imgH="3352674" progId="Prism6.Document">
                  <p:link updateAutomatic="1"/>
                </p:oleObj>
              </mc:Choice>
              <mc:Fallback>
                <p:oleObj name="Prism 6" r:id="rId16" imgW="2424073" imgH="3352674" progId="Prism6.Document">
                  <p:link updateAutomatic="1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560821" y="2610793"/>
                        <a:ext cx="1613940" cy="2232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779864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4</TotalTime>
  <Words>61</Words>
  <Application>Microsoft Office PowerPoint</Application>
  <PresentationFormat>Personalizado</PresentationFormat>
  <Paragraphs>23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Vínculos</vt:lpstr>
      </vt:variant>
      <vt:variant>
        <vt:i4>3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Times New Roman</vt:lpstr>
      <vt:lpstr>Tema de Office</vt:lpstr>
      <vt:lpstr>file:///C:\Users\LEDESMA\Desktop\Yadira\Gráfica%20dexa%20y%20curva%20tces%20120325\Pérdida%20de%20peso%20CURVA%20TcES.pzf!G1</vt:lpstr>
      <vt:lpstr>file:///C:\Users\LEDESMA\Desktop\Yadira\Gráfica%20dexa%20y%20curva%20tces%20120325\DAI%20DEXA%20%20y%20Curva%20TcES(10).pzf!G1</vt:lpstr>
      <vt:lpstr>file:///C:\Users\LEDESMA\Downloads\Longitud%20colon%20curva%20TcES170325.pzf!G0</vt:lpstr>
      <vt:lpstr>Presentación de PowerPoint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DESMA</dc:creator>
  <cp:lastModifiedBy>YADIRA LEDESMA SOTO</cp:lastModifiedBy>
  <cp:revision>30</cp:revision>
  <dcterms:created xsi:type="dcterms:W3CDTF">2025-03-16T21:41:28Z</dcterms:created>
  <dcterms:modified xsi:type="dcterms:W3CDTF">2025-03-29T01:43:25Z</dcterms:modified>
</cp:coreProperties>
</file>